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9AF1DF3-F80B-43FA-8717-990289638F80}" v="8" dt="2022-11-03T11:39:09.7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9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20" y="6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rota\Dropbox\Flash_paper\Table%20S1_v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baseline="0"/>
              <a:t>Solved cases by clinical categor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4951881014873E-2"/>
          <c:y val="0.18039406532516766"/>
          <c:w val="0.88498840769903764"/>
          <c:h val="0.56412766112569257"/>
        </c:manualLayout>
      </c:layout>
      <c:barChart>
        <c:barDir val="col"/>
        <c:grouping val="stacked"/>
        <c:varyColors val="0"/>
        <c:ser>
          <c:idx val="1"/>
          <c:order val="0"/>
          <c:tx>
            <c:strRef>
              <c:f>Sheet2!$B$38</c:f>
              <c:strCache>
                <c:ptCount val="1"/>
                <c:pt idx="0">
                  <c:v>Solved case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A$39:$A$43</c:f>
              <c:strCache>
                <c:ptCount val="5"/>
                <c:pt idx="0">
                  <c:v>Decision about management</c:v>
                </c:pt>
                <c:pt idx="1">
                  <c:v>Decision about BMT</c:v>
                </c:pt>
                <c:pt idx="2">
                  <c:v>Decision about liver transplant</c:v>
                </c:pt>
                <c:pt idx="3">
                  <c:v>Decision about DNR</c:v>
                </c:pt>
                <c:pt idx="4">
                  <c:v>Decision about termination</c:v>
                </c:pt>
              </c:strCache>
            </c:strRef>
          </c:cat>
          <c:val>
            <c:numRef>
              <c:f>Sheet2!$B$39:$B$43</c:f>
              <c:numCache>
                <c:formatCode>0%</c:formatCode>
                <c:ptCount val="5"/>
                <c:pt idx="0">
                  <c:v>0.32</c:v>
                </c:pt>
                <c:pt idx="1">
                  <c:v>0.32</c:v>
                </c:pt>
                <c:pt idx="2">
                  <c:v>0.19</c:v>
                </c:pt>
                <c:pt idx="3">
                  <c:v>0.13</c:v>
                </c:pt>
                <c:pt idx="4">
                  <c:v>0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C7-4F19-B7B6-3BFFDCA5A0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9602176"/>
        <c:axId val="179603712"/>
      </c:barChart>
      <c:catAx>
        <c:axId val="179602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603712"/>
        <c:crosses val="autoZero"/>
        <c:auto val="0"/>
        <c:lblAlgn val="ctr"/>
        <c:lblOffset val="100"/>
        <c:noMultiLvlLbl val="0"/>
      </c:catAx>
      <c:valAx>
        <c:axId val="1796037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602176"/>
        <c:crosses val="autoZero"/>
        <c:crossBetween val="between"/>
      </c:valAx>
      <c:spPr>
        <a:noFill/>
        <a:ln>
          <a:solidFill>
            <a:schemeClr val="accent1">
              <a:lumMod val="60000"/>
              <a:lumOff val="40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B25CB9-914D-13CF-24C9-56E9CBA905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E711E0-EA6B-C9FD-F025-864125FDC6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872741-FFB0-42A8-390D-E35D93127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E14B37-DD04-1310-0721-853354D1B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BB1127-270B-AB9C-D72E-C8D7F97E7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805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ED5B92-F92D-2018-3FA4-33708570EF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F56086-1083-1CD1-32DB-018CD74E5C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766891-664F-4A34-0110-6C683BB3E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564E2C-C3F4-A4AD-A6F8-672D111E3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7EEBAE-D05B-42A7-B118-6F5045B14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621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1823F8-9C48-FF61-5E4C-3236CB3423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7BEEC3-F312-98A8-D294-4A79FB1BD1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6185DD-84C8-D757-4ADF-B6F9E0D96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057B9F-FA34-CC7E-1E76-EDAB4BB66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E17C1A-D707-D26F-728B-6063BE70B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333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44AC2F-0E11-3380-8704-A7E64D16E1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71D520-07F4-E9F4-73EC-D82DED44EC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B4CB3D-1239-2A49-2E8E-B169E9C66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64FFC2-771F-AC37-0004-B37F51F5D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100389-5500-A1D1-4672-00C853E81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233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1DE5CB-BF64-6CE4-FD48-EDD7E02567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EB8EE9-FFF8-F5C3-0698-A5A3496FE6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7EA0EE-6CA7-A1D8-BF38-A3D758FD8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22CCDC-8E3A-7E20-AA00-E4AE6FFD0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4478B8-7D83-996E-495C-3FC0F46BC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141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BFEB7D-16EA-193D-5210-DA6F61B755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3D81EA-A8B5-F4AD-EB45-7EFDAAF817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177450-5DEF-4C5F-ED82-1C59916449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8C432D-D870-A4C7-C29C-24D2A2151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A847D9-7E0E-A86D-0691-74FE2B2046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078EC3-9A7B-C800-7E78-70544EEA1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668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1767A4-3C28-539D-A87A-E106E06A57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89772D-9E25-2A8F-18CB-1A27FB921A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62EEBB-9EAB-5AA9-9E0B-8084285C1E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9C18F9-659B-77FA-64BA-693F9662D7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EC100B-95E2-B480-CB0A-77269CDB0A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CDAFAD-658A-1E13-3452-7CAA816C2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DC8BB1F-F55D-8F19-42C3-CF19A2C45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730815-347F-B8E0-D364-B65E9FF9C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793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984044-3A1C-324D-9FAA-87CECEDB49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463C6F6-D99E-4DED-AABD-C8A0C8168D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2736D6-9FDD-3F2C-0BAD-0C6B08878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C076BF-85F5-EA49-CD9B-0E059B6C8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238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637461-E4E6-3659-E88B-E3B5540C3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D4DA3D1-93A0-55B2-3373-3F9AA251A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44E1A2-94FE-6787-FF42-9D878450E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503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6F664A-9CD4-A58A-B99F-F6DE5AE8B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ECBC62-142A-A620-C734-34AEBBC1AF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E9FABB-3E2F-98F0-4693-AE6102305A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2FA2FB-9D53-6ED7-ED32-272BD7547C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8D5FBB-E060-AB43-758E-67844BABE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0BD0BF-04D8-BD1A-0F23-ED2C2B0ED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358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381A96-5253-7B45-A984-BCC2F999EA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4204AD-0EF5-ED53-4EA8-B7581BB722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8D3BA9-A111-76E8-7996-3A3C5ADF33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E10B1F-1CC1-6CC9-8AA2-5007AF786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128337-A6B2-0FE3-E6FA-0A763B889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C6DFAF-E75F-5B68-A3FE-83131C70C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720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35B0C4-DA71-1A96-D17D-17254C6960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FAC481-03E5-9908-5DE8-FCA9B3EC9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277EFE-2756-A148-9C43-92ACAA0F0E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3D755-250F-4A40-9133-055D5A458A38}" type="datetimeFigureOut">
              <a:rPr lang="en-US" smtClean="0"/>
              <a:t>6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8A6771-2C9D-CF9A-88EE-3424E4CAAA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0B7641-8CFD-0DC9-9E0E-A3DF0CE6DF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0CCCB-950A-4F79-A34A-C78EECEEE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433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51BDA9A1-CF2F-ABD7-6EF8-3F725E5DF5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3275166"/>
              </p:ext>
            </p:extLst>
          </p:nvPr>
        </p:nvGraphicFramePr>
        <p:xfrm>
          <a:off x="914401" y="447450"/>
          <a:ext cx="10403306" cy="7190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7E933FC-FA61-165F-72AF-54456B70640E}"/>
              </a:ext>
            </a:extLst>
          </p:cNvPr>
          <p:cNvSpPr txBox="1"/>
          <p:nvPr/>
        </p:nvSpPr>
        <p:spPr>
          <a:xfrm>
            <a:off x="0" y="0"/>
            <a:ext cx="65749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 S1. Breakdown of the diagnostic yield by clinical indication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6710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rota Monies</dc:creator>
  <cp:lastModifiedBy>Rene Aanstoot</cp:lastModifiedBy>
  <cp:revision>8</cp:revision>
  <dcterms:created xsi:type="dcterms:W3CDTF">2022-09-24T12:51:52Z</dcterms:created>
  <dcterms:modified xsi:type="dcterms:W3CDTF">2023-06-15T11:47:17Z</dcterms:modified>
</cp:coreProperties>
</file>